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howGuides="1">
      <p:cViewPr varScale="1">
        <p:scale>
          <a:sx n="124" d="100"/>
          <a:sy n="124" d="100"/>
        </p:scale>
        <p:origin x="544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520D9B-B91C-3301-8F6C-A9D11F376C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B73536-595B-9DDD-3A6E-56FAA055B1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C652E6-DDF9-9AFE-876A-04A818C27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2CDEC4-C53D-E19E-F161-FC9D8544A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62C27F-6140-B199-B957-61D977542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239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8F358C-B36E-FECB-192A-83DEA6AA54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70B8BB-5990-4CD3-BB54-BCC8F69790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B38DBC-B8E3-AD36-BDE6-4E8F8BADC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EEDE0D-D72F-2098-7906-1307E82CD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E8727-F2D9-1028-3DF0-80498B416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553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CFC28A6-A569-FB4E-C689-0D279A3575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F0629-D707-D17F-61CF-FAF3858D1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015F66-95D1-BC8B-636D-F3F436FBF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C7098B-A398-1D4F-3CE1-35618D54F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2D9974-CDC8-A431-FD8F-9660C0CE5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931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8454D6-A298-F820-8454-74A2C0DF26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3B11E0-068B-57EB-4AB9-3C579D964B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EEAF94-C4C1-BE15-E5FA-D2F96214B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38A1C2-DFE1-9091-0D64-B6B28F296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1A658B-E26E-236A-301F-6641BCB84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67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0C0579-C70E-0DCC-33B9-824594B35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124B6E-0B80-FD2F-8B5A-F4AC524A8C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5275C7-1303-84BB-CAAF-04AFCB9B1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B02E42-0D63-ADF6-9FC2-3DDF21E0C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0A5793-AC84-EB30-41F1-46DD3C210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555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0EABB1-5909-CBBA-B873-EC53CC811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FFC5BE-CDE9-0ECB-B194-4AA0D9B2E1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FD3368-02B1-EBAB-C472-E521D854AA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291748-A566-3F66-1D20-61EBE5E7AB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A2EB90-D25E-E058-9DE8-30FCA027F0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89549F-C5CB-6BC9-0763-CAD7A9B9E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422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2E12FA-9608-7F70-6552-DB7DD64376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A2F74D-7EB3-D5EF-4A9F-595E4B98E6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1732C4-74B5-E490-D637-323883A5F8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423474-0D25-3AD6-45A4-F933E02955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EA1A76-4274-5338-DF2C-31949B36C5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A00A04-08C3-45FA-ACDF-06BE65F5A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FBB400-0DAC-8271-70B0-06242261F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1021F39-B594-6707-792E-2109F1DAE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58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E2192A-010C-3EB1-603E-AAD5FBD658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6CD54D-3070-E6E2-4091-64BE861B1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0FD714B-4FC2-F67D-A01A-E23A59A3B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DFDF42F-0647-8FB4-0243-EBB2126C4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569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B302F8-6558-E09F-6F20-99A90C1A3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E8FBB68-6E80-866D-BDBE-0044A1E59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EC8C1A-838D-A570-0799-F1E25A384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788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2EFC21-9930-4E79-1363-493DA5972C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B613DB-AF97-56E8-053A-6145DB00FC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D20773-56D1-58FE-FD58-FFF81AD894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914F04-6490-1F04-BF73-09DAD629F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7DF578-64F3-6240-4287-6DE47C911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994473-B428-B3DD-68ED-8DD48315A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551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253DF6-3613-9132-04A8-04B32A77F8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BFF20FD-DA57-CDCA-418B-A11EF82DD2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D99A09-A247-C567-461F-E35820941A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9647B0-2C8D-0BB7-18AC-C8354C24B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539ECF-1A79-2436-AE57-AA0876C06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E88F81-4319-1121-013F-26BD596E9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561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7DAC3E-7542-CE26-DD82-EE140D65F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F72C9D-90EE-5A5C-6556-E0939AC1DB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1F4BFB-EAFE-98F3-F8F2-436F74D38F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8862A-6933-B543-A8E7-E8FF9EC1A66B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A93E3A-E51F-7643-DB3D-FE8CBF0D41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147B1D-5EB7-92C2-7161-B0F1B093C8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DB927-2AB0-FD4C-A65C-5CBEB0E9E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35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8ED5D0F-5895-444F-056D-816A12DB02A5}"/>
              </a:ext>
            </a:extLst>
          </p:cNvPr>
          <p:cNvGrpSpPr>
            <a:grpSpLocks noChangeAspect="1"/>
          </p:cNvGrpSpPr>
          <p:nvPr/>
        </p:nvGrpSpPr>
        <p:grpSpPr>
          <a:xfrm>
            <a:off x="979716" y="1267880"/>
            <a:ext cx="4963291" cy="3657600"/>
            <a:chOff x="1905000" y="533400"/>
            <a:chExt cx="8152206" cy="6007608"/>
          </a:xfrm>
        </p:grpSpPr>
        <p:pic>
          <p:nvPicPr>
            <p:cNvPr id="4" name="Picture 3" descr="Emetin UV spectra.JPG"/>
            <p:cNvPicPr>
              <a:picLocks noChangeAspect="1"/>
            </p:cNvPicPr>
            <p:nvPr/>
          </p:nvPicPr>
          <p:blipFill>
            <a:blip r:embed="rId2" cstate="print"/>
            <a:srcRect t="4676" r="3662" b="4676"/>
            <a:stretch>
              <a:fillRect/>
            </a:stretch>
          </p:blipFill>
          <p:spPr>
            <a:xfrm>
              <a:off x="1905000" y="533400"/>
              <a:ext cx="8152206" cy="6007608"/>
            </a:xfrm>
            <a:prstGeom prst="rect">
              <a:avLst/>
            </a:prstGeom>
          </p:spPr>
        </p:pic>
        <p:pic>
          <p:nvPicPr>
            <p:cNvPr id="5" name="Picture 4" descr="Emetine UV conc dependence.JPG"/>
            <p:cNvPicPr>
              <a:picLocks noChangeAspect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2813" t="8571" r="6563" b="6122"/>
            <a:stretch>
              <a:fillRect/>
            </a:stretch>
          </p:blipFill>
          <p:spPr>
            <a:xfrm>
              <a:off x="5943600" y="1143000"/>
              <a:ext cx="3383648" cy="2438400"/>
            </a:xfrm>
            <a:prstGeom prst="rect">
              <a:avLst/>
            </a:prstGeom>
          </p:spPr>
        </p:pic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AA2B197E-9272-2A85-CBE2-216DD735048C}"/>
              </a:ext>
            </a:extLst>
          </p:cNvPr>
          <p:cNvGrpSpPr>
            <a:grpSpLocks noChangeAspect="1"/>
          </p:cNvGrpSpPr>
          <p:nvPr/>
        </p:nvGrpSpPr>
        <p:grpSpPr>
          <a:xfrm>
            <a:off x="6096000" y="1267880"/>
            <a:ext cx="4831644" cy="3657600"/>
            <a:chOff x="304800" y="228600"/>
            <a:chExt cx="8153400" cy="6172200"/>
          </a:xfrm>
        </p:grpSpPr>
        <p:pic>
          <p:nvPicPr>
            <p:cNvPr id="6" name="Picture 5" descr="Emetine Fluor Spectra.PNG">
              <a:extLst>
                <a:ext uri="{FF2B5EF4-FFF2-40B4-BE49-F238E27FC236}">
                  <a16:creationId xmlns:a16="http://schemas.microsoft.com/office/drawing/2014/main" id="{BA69F14D-DEC9-30DA-9272-AB368831047A}"/>
                </a:ext>
              </a:extLst>
            </p:cNvPr>
            <p:cNvPicPr/>
            <p:nvPr/>
          </p:nvPicPr>
          <p:blipFill>
            <a:blip r:embed="rId4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8437" t="7347" r="10312" b="4898"/>
            <a:stretch>
              <a:fillRect/>
            </a:stretch>
          </p:blipFill>
          <p:spPr>
            <a:xfrm>
              <a:off x="304800" y="228600"/>
              <a:ext cx="8153400" cy="6172200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DA968C32-7FCC-4C66-653D-4C7454DB5521}"/>
                </a:ext>
              </a:extLst>
            </p:cNvPr>
            <p:cNvSpPr/>
            <p:nvPr/>
          </p:nvSpPr>
          <p:spPr>
            <a:xfrm>
              <a:off x="6337738" y="651642"/>
              <a:ext cx="1629103" cy="16291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9E1449B7-40E1-45B2-DC32-5A572C03F5FA}"/>
              </a:ext>
            </a:extLst>
          </p:cNvPr>
          <p:cNvSpPr txBox="1"/>
          <p:nvPr/>
        </p:nvSpPr>
        <p:spPr>
          <a:xfrm>
            <a:off x="1465405" y="98074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F60804D-CC2D-D449-9BB4-2F73A9A76FC9}"/>
              </a:ext>
            </a:extLst>
          </p:cNvPr>
          <p:cNvSpPr txBox="1"/>
          <p:nvPr/>
        </p:nvSpPr>
        <p:spPr>
          <a:xfrm>
            <a:off x="6440175" y="89854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C410EE-A91E-2663-6EEC-329DC8F752C6}"/>
              </a:ext>
            </a:extLst>
          </p:cNvPr>
          <p:cNvSpPr txBox="1"/>
          <p:nvPr/>
        </p:nvSpPr>
        <p:spPr>
          <a:xfrm>
            <a:off x="1465405" y="5218978"/>
            <a:ext cx="9462239" cy="85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ts val="15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UV/Vis Absorbance and Fluorescence Profiles of Emetine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nel A: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mily of UV/Vis absorbance spectra spanning the concentration range of 10 µM - 2.5 mM in ethanol.  The inset presents a concentration-dependent analysis of absorbance values recorded at 280 nm and the resultant linear correlation;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nel B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luorescence emission spectra monitored as a function of excitation wavelength recorded at 280 nm (blue), 285 nm (magenta), 290 nm (purple), and 295 nm (orange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3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Rosenquist</dc:creator>
  <cp:lastModifiedBy>Thomas Rosenquist</cp:lastModifiedBy>
  <cp:revision>2</cp:revision>
  <dcterms:created xsi:type="dcterms:W3CDTF">2023-08-24T19:25:31Z</dcterms:created>
  <dcterms:modified xsi:type="dcterms:W3CDTF">2023-08-24T19:32:17Z</dcterms:modified>
</cp:coreProperties>
</file>